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4" d="100"/>
          <a:sy n="154" d="100"/>
        </p:scale>
        <p:origin x="53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hi, Aniket Sunil" userId="99c22df6-eccd-47fd-9b08-c584eb42b50d" providerId="ADAL" clId="{CEA58B46-2671-4709-9257-5C7F961ACCE1}"/>
    <pc:docChg chg="undo addSld modSld">
      <pc:chgData name="Joshi, Aniket Sunil" userId="99c22df6-eccd-47fd-9b08-c584eb42b50d" providerId="ADAL" clId="{CEA58B46-2671-4709-9257-5C7F961ACCE1}" dt="2025-08-23T19:42:31.485" v="6" actId="1076"/>
      <pc:docMkLst>
        <pc:docMk/>
      </pc:docMkLst>
      <pc:sldChg chg="addSp delSp modSp add">
        <pc:chgData name="Joshi, Aniket Sunil" userId="99c22df6-eccd-47fd-9b08-c584eb42b50d" providerId="ADAL" clId="{CEA58B46-2671-4709-9257-5C7F961ACCE1}" dt="2025-08-23T19:42:31.485" v="6" actId="1076"/>
        <pc:sldMkLst>
          <pc:docMk/>
          <pc:sldMk cId="1316418841" sldId="256"/>
        </pc:sldMkLst>
        <pc:spChg chg="del">
          <ac:chgData name="Joshi, Aniket Sunil" userId="99c22df6-eccd-47fd-9b08-c584eb42b50d" providerId="ADAL" clId="{CEA58B46-2671-4709-9257-5C7F961ACCE1}" dt="2025-08-23T19:41:53.056" v="1"/>
          <ac:spMkLst>
            <pc:docMk/>
            <pc:sldMk cId="1316418841" sldId="256"/>
            <ac:spMk id="2" creationId="{8E740010-EEFB-4917-AF7D-8916985073F5}"/>
          </ac:spMkLst>
        </pc:spChg>
        <pc:spChg chg="del">
          <ac:chgData name="Joshi, Aniket Sunil" userId="99c22df6-eccd-47fd-9b08-c584eb42b50d" providerId="ADAL" clId="{CEA58B46-2671-4709-9257-5C7F961ACCE1}" dt="2025-08-23T19:41:53.056" v="1"/>
          <ac:spMkLst>
            <pc:docMk/>
            <pc:sldMk cId="1316418841" sldId="256"/>
            <ac:spMk id="3" creationId="{0669CFE8-FED2-4FD2-A0F9-99C7F6579F62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9" creationId="{B2958875-912D-42B5-BEB4-71D22D653D90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1" creationId="{52B79F71-052A-4D83-A2B5-5B63D0DDA60B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2" creationId="{A89DF3A6-7079-42ED-8B54-D90EB2C466FE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3" creationId="{5082F751-3F78-4B24-9BD5-209EF0FB1A73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5" creationId="{2BA86718-FBB5-413D-8295-E8262BBDDBF0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7" creationId="{3A5F4F9A-26DB-48E4-9225-D6CE29297A87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19" creationId="{71EA9895-5DFC-4C1E-8301-3FA144A2423B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20" creationId="{540F318B-A21F-446B-A2C7-1461FF5998BB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22" creationId="{00832799-DE54-45AC-B909-BEE45696419F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24" creationId="{F538523F-885F-453F-BBB7-52C516E7D66E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27" creationId="{5D1DBF43-7021-4ABE-B414-9BA72CF39485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28" creationId="{FC6EF261-ED64-4ECE-9414-C893048B17CA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0" creationId="{888B2574-DD3B-4012-B8BB-CD4D436F80F1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3" creationId="{549BAA0E-F5A9-4192-94BD-664CEFE97DB3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4" creationId="{65230F06-4766-43E8-82CB-0666CB936C2C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5" creationId="{6CF51931-87FA-482D-AB01-EEB874389D0C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6" creationId="{BEBBE908-541D-4207-95DC-87B5F1176598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38" creationId="{0D84D034-C57B-429B-BA43-8A066F5D7F46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40" creationId="{2CF6C257-2CD0-4614-BEFC-3E66CBC82A94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42" creationId="{9C83FB9E-675B-4209-839C-46AC47CC7FBE}"/>
          </ac:spMkLst>
        </pc:spChg>
        <pc:spChg chg="add mod">
          <ac:chgData name="Joshi, Aniket Sunil" userId="99c22df6-eccd-47fd-9b08-c584eb42b50d" providerId="ADAL" clId="{CEA58B46-2671-4709-9257-5C7F961ACCE1}" dt="2025-08-23T19:42:19.396" v="3" actId="1076"/>
          <ac:spMkLst>
            <pc:docMk/>
            <pc:sldMk cId="1316418841" sldId="256"/>
            <ac:spMk id="43" creationId="{88C2FC95-FB43-45D3-997C-C8B07A163B7E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46" creationId="{5C0B4041-B527-4103-A17D-D1291CACF0FB}"/>
          </ac:spMkLst>
        </pc:spChg>
        <pc:spChg chg="add mod">
          <ac:chgData name="Joshi, Aniket Sunil" userId="99c22df6-eccd-47fd-9b08-c584eb42b50d" providerId="ADAL" clId="{CEA58B46-2671-4709-9257-5C7F961ACCE1}" dt="2025-08-23T19:42:31.485" v="6" actId="1076"/>
          <ac:spMkLst>
            <pc:docMk/>
            <pc:sldMk cId="1316418841" sldId="256"/>
            <ac:spMk id="47" creationId="{29711C4D-E454-438D-9B84-F97D6E8D811F}"/>
          </ac:spMkLst>
        </pc:sp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4" creationId="{09BE3667-89A6-443B-89BC-F18B69021F7A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5" creationId="{991E53F8-1623-4B4B-9A22-626EB12C1254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6" creationId="{B1516D45-6C7D-4CE6-8022-7F36EF3F45A1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7" creationId="{9CB3207E-A424-4F6E-992F-532CFFE8445A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8" creationId="{CD52AAE9-9C8F-4348-AF88-E0EBD8F5C330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31" creationId="{26B7B153-6ECD-47D5-9C22-C5AD3184869C}"/>
          </ac:picMkLst>
        </pc:picChg>
        <pc:picChg chg="add mod">
          <ac:chgData name="Joshi, Aniket Sunil" userId="99c22df6-eccd-47fd-9b08-c584eb42b50d" providerId="ADAL" clId="{CEA58B46-2671-4709-9257-5C7F961ACCE1}" dt="2025-08-23T19:42:31.485" v="6" actId="1076"/>
          <ac:picMkLst>
            <pc:docMk/>
            <pc:sldMk cId="1316418841" sldId="256"/>
            <ac:picMk id="44" creationId="{743E1E22-9969-4723-8FC2-878CE2B7F08F}"/>
          </ac:picMkLst>
        </pc:pic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10" creationId="{5DE7BC5F-A402-427D-90E5-482788C9491A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14" creationId="{D27D0313-CD79-4110-A6B0-3D957E1B5D0A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16" creationId="{E905220F-1EDB-41B7-838D-653042641927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18" creationId="{53BCB65E-0913-41C5-86BA-901D2FC2FB6E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21" creationId="{39193937-0308-4AD6-8BBE-4031828276B9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23" creationId="{94B8A1B5-00A5-4BDC-88CE-CC1266D2DB3B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25" creationId="{2A9D9385-BF2A-47E3-A34A-4C657B1EB62D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26" creationId="{FE9CAD6C-62B5-45B8-BACF-F65360D36213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29" creationId="{69A14265-88AF-4040-A9CE-016E60B359D7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32" creationId="{B9E923CF-A987-4F82-B65F-CA6D46B7C4F8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37" creationId="{D805C75D-0479-4571-BFE2-25E9A44AD917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39" creationId="{C940B658-7949-40D9-BFC6-5D263C4E507B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41" creationId="{2F5E4AB6-F3E1-4FDA-A133-7F75B9574F49}"/>
          </ac:cxnSpMkLst>
        </pc:cxnChg>
        <pc:cxnChg chg="add mod">
          <ac:chgData name="Joshi, Aniket Sunil" userId="99c22df6-eccd-47fd-9b08-c584eb42b50d" providerId="ADAL" clId="{CEA58B46-2671-4709-9257-5C7F961ACCE1}" dt="2025-08-23T19:42:31.485" v="6" actId="1076"/>
          <ac:cxnSpMkLst>
            <pc:docMk/>
            <pc:sldMk cId="1316418841" sldId="256"/>
            <ac:cxnSpMk id="45" creationId="{2CD79D18-238B-4514-8483-E4D3102C502D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03C5E3-A6A5-4E34-9B83-7E1F4D4189C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106D2EA-AC79-42FC-B0DC-31306FEB62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692285-7259-46EA-AEE0-7AF77E05F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E38D9A-4DEC-4F71-BFD8-BE0399B7C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556DDE-F977-47EB-9690-815A911EC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29846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61535B-E6C8-46DE-911F-70F5394A63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61766A-F28E-40D6-B8A0-C9A3B13288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347F6-6730-489C-B878-121FE0A35C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DF5912-1159-4E66-A5D3-72F3E63D25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A9A4C-B5F6-4001-B4F3-AEEB0CA048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475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67EDDD6-5B62-4692-8C07-8CD906B5A4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CF16A-32CB-4ADA-A071-FAA7A39EE2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7E0F4-3405-4E30-8D9A-0AEB74AEA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DAC596-B805-4234-922E-D760FB282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35F60-6ADF-45EB-9660-E5B972B68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467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3B025-8B6E-4407-A040-E2E47A7263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8E7BCB-CB27-4CD8-93CF-D5EB92FE86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5EB441-1C90-40A0-90C6-53A962D67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8C018A-6860-4D5B-AF72-D0D00F5784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269364-FA9B-4E68-B98F-5BCF75AC51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380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BDB72-6F0F-44A6-BA10-F616F84C88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671A68-7F3F-4032-A0A2-268163EF13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B0161E-815C-4EDF-8465-2D16F6438D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D53708-BAFC-499D-AB17-F799C0C6D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C2AC68-B07C-424E-93FF-10299099E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370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601B0-08DA-4758-975A-95C451C354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D2E4D3-3A70-4A09-B861-03A7BA6D55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E83EF8-0B38-453E-A4C8-AE80060CC34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34D3D9-7C59-406C-9166-382FE150E5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82F8AA-71E9-4E1F-84A3-84D6FD4F21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655FC9-96E7-4485-972E-6D6628CBE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03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8B107C-953B-41B8-97B7-18A698F74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F5B040-344D-4E4A-9538-F69D119E87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F7B9A4-3D74-4761-BD05-8EA77F157E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5363ADA-4C9F-455B-8475-EB2374CD61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19F58A-7814-4C7E-873D-03614D58308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1ADE90-0CEC-4D9C-B680-E7F35D03A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1BB643A-5017-4FDD-BE55-017346EB6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0CFCEB-092C-463C-9459-57FC7B0F0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719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847B6D-E271-44D0-B6E0-CDB9E3849F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294962-5CC3-42E0-9A87-0FDFEEF6B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758834-FFCE-4B9F-87AF-030563FD52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14770E-A81B-4067-AC6B-0070CD0817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2991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968F57-005A-45D2-8E46-0F075FC3B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C9B810-FFFF-41CA-A5A1-D19EBFB0B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F78BA46-4451-4438-97D6-5FA5131BBC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355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2D341-207A-4B9D-AC13-F2EE58E4C6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B41898-3E84-497B-AC7F-45BAB5AE96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FFB377-DBA5-4FA6-9C55-7AC5E76393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7CFB9C-8C86-44D1-ABA2-92AEE57A2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5ACC62-EFB0-4AB9-8585-E856B12F1C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78DB5D-F3E0-4F7B-8A0B-5B77452E2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001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228284-E085-4B78-82F9-F9FB8E0A59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56DBB24-649C-432D-8FB9-644BC803C4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9532D1-2B2F-4057-9506-D652C70B31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F76160-6BA9-46D7-A070-6D9203AAB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D51B9D-0EFE-40F9-A1A9-9E18C3560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0AF29C-D6CC-4071-B9CB-1EB98C685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896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B3529E-E159-4EA3-8DCC-D5069D3E99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85C2ED-1358-421A-BE35-C441020620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79A081-6861-426B-A3B2-4851E82E41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7B0FFC-F176-4134-A8A0-D5CA93F24427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A18D45-FF1C-41E9-B698-8AD1DBCB43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652FC6-4C9C-4493-B50C-D85F83F12C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37E2BC-3AC7-4794-80A2-DA922EB99C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5596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9BE3667-89A6-443B-89BC-F18B69021F7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5" t="4518" r="868" b="8581"/>
          <a:stretch/>
        </p:blipFill>
        <p:spPr>
          <a:xfrm>
            <a:off x="1734517" y="5097713"/>
            <a:ext cx="3005592" cy="7171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91E53F8-1623-4B4B-9A22-626EB12C125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59" t="6207" r="1418" b="18822"/>
          <a:stretch/>
        </p:blipFill>
        <p:spPr>
          <a:xfrm>
            <a:off x="1566915" y="4550617"/>
            <a:ext cx="3244720" cy="4924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1516D45-6C7D-4CE6-8022-7F36EF3F45A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0" t="10922" r="2455" b="16027"/>
          <a:stretch/>
        </p:blipFill>
        <p:spPr>
          <a:xfrm>
            <a:off x="1635283" y="3037440"/>
            <a:ext cx="3241528" cy="6481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CB3207E-A424-4F6E-992F-532CFFE8445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3" t="4198" r="1434" b="3101"/>
          <a:stretch/>
        </p:blipFill>
        <p:spPr>
          <a:xfrm>
            <a:off x="1682891" y="640074"/>
            <a:ext cx="2957803" cy="14396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D52AAE9-9C8F-4348-AF88-E0EBD8F5C33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" t="6626" r="5670" b="7602"/>
          <a:stretch/>
        </p:blipFill>
        <p:spPr>
          <a:xfrm>
            <a:off x="1694317" y="5888178"/>
            <a:ext cx="3005592" cy="7489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2958875-912D-42B5-BEB4-71D22D653D90}"/>
              </a:ext>
            </a:extLst>
          </p:cNvPr>
          <p:cNvSpPr txBox="1"/>
          <p:nvPr/>
        </p:nvSpPr>
        <p:spPr>
          <a:xfrm>
            <a:off x="4685417" y="6007406"/>
            <a:ext cx="851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5DE7BC5F-A402-427D-90E5-482788C9491A}"/>
              </a:ext>
            </a:extLst>
          </p:cNvPr>
          <p:cNvCxnSpPr/>
          <p:nvPr/>
        </p:nvCxnSpPr>
        <p:spPr>
          <a:xfrm>
            <a:off x="1577413" y="5948223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52B79F71-052A-4D83-A2B5-5B63D0DDA60B}"/>
              </a:ext>
            </a:extLst>
          </p:cNvPr>
          <p:cNvSpPr txBox="1"/>
          <p:nvPr/>
        </p:nvSpPr>
        <p:spPr>
          <a:xfrm>
            <a:off x="1284777" y="5814875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89DF3A6-7079-42ED-8B54-D90EB2C466FE}"/>
              </a:ext>
            </a:extLst>
          </p:cNvPr>
          <p:cNvSpPr txBox="1"/>
          <p:nvPr/>
        </p:nvSpPr>
        <p:spPr>
          <a:xfrm>
            <a:off x="1126115" y="265590"/>
            <a:ext cx="9208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W (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82F751-3F78-4B24-9BD5-209EF0FB1A73}"/>
              </a:ext>
            </a:extLst>
          </p:cNvPr>
          <p:cNvSpPr txBox="1"/>
          <p:nvPr/>
        </p:nvSpPr>
        <p:spPr>
          <a:xfrm>
            <a:off x="4624373" y="953937"/>
            <a:ext cx="126453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err="1">
                <a:latin typeface="Times New Roman" panose="02020603050405020304" pitchFamily="18" charset="0"/>
                <a:cs typeface="Times New Roman" panose="02020603050405020304" pitchFamily="18" charset="0"/>
              </a:rPr>
              <a:t>Ub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jugated proteins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D27D0313-CD79-4110-A6B0-3D957E1B5D0A}"/>
              </a:ext>
            </a:extLst>
          </p:cNvPr>
          <p:cNvCxnSpPr/>
          <p:nvPr/>
        </p:nvCxnSpPr>
        <p:spPr>
          <a:xfrm>
            <a:off x="1605404" y="1438612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2BA86718-FBB5-413D-8295-E8262BBDDBF0}"/>
              </a:ext>
            </a:extLst>
          </p:cNvPr>
          <p:cNvSpPr txBox="1"/>
          <p:nvPr/>
        </p:nvSpPr>
        <p:spPr>
          <a:xfrm>
            <a:off x="1312768" y="1305264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E905220F-1EDB-41B7-838D-653042641927}"/>
              </a:ext>
            </a:extLst>
          </p:cNvPr>
          <p:cNvCxnSpPr/>
          <p:nvPr/>
        </p:nvCxnSpPr>
        <p:spPr>
          <a:xfrm>
            <a:off x="1605404" y="1171862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3A5F4F9A-26DB-48E4-9225-D6CE29297A87}"/>
              </a:ext>
            </a:extLst>
          </p:cNvPr>
          <p:cNvSpPr txBox="1"/>
          <p:nvPr/>
        </p:nvSpPr>
        <p:spPr>
          <a:xfrm>
            <a:off x="1312768" y="1038514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3BCB65E-0913-41C5-86BA-901D2FC2FB6E}"/>
              </a:ext>
            </a:extLst>
          </p:cNvPr>
          <p:cNvCxnSpPr/>
          <p:nvPr/>
        </p:nvCxnSpPr>
        <p:spPr>
          <a:xfrm>
            <a:off x="1605404" y="810286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1EA9895-5DFC-4C1E-8301-3FA144A2423B}"/>
              </a:ext>
            </a:extLst>
          </p:cNvPr>
          <p:cNvSpPr txBox="1"/>
          <p:nvPr/>
        </p:nvSpPr>
        <p:spPr>
          <a:xfrm>
            <a:off x="1208882" y="676938"/>
            <a:ext cx="485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40F318B-A21F-446B-A2C7-1461FF5998BB}"/>
              </a:ext>
            </a:extLst>
          </p:cNvPr>
          <p:cNvSpPr txBox="1"/>
          <p:nvPr/>
        </p:nvSpPr>
        <p:spPr>
          <a:xfrm>
            <a:off x="2763607" y="327997"/>
            <a:ext cx="6909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Vehicle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39193937-0308-4AD6-8BBE-4031828276B9}"/>
              </a:ext>
            </a:extLst>
          </p:cNvPr>
          <p:cNvCxnSpPr/>
          <p:nvPr/>
        </p:nvCxnSpPr>
        <p:spPr>
          <a:xfrm>
            <a:off x="2791328" y="571071"/>
            <a:ext cx="60682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0832799-DE54-45AC-B909-BEE45696419F}"/>
              </a:ext>
            </a:extLst>
          </p:cNvPr>
          <p:cNvSpPr txBox="1"/>
          <p:nvPr/>
        </p:nvSpPr>
        <p:spPr>
          <a:xfrm>
            <a:off x="3640894" y="327997"/>
            <a:ext cx="5404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8C 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4B8A1B5-00A5-4BDC-88CE-CC1266D2DB3B}"/>
              </a:ext>
            </a:extLst>
          </p:cNvPr>
          <p:cNvCxnSpPr/>
          <p:nvPr/>
        </p:nvCxnSpPr>
        <p:spPr>
          <a:xfrm>
            <a:off x="3501950" y="571071"/>
            <a:ext cx="80768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F538523F-885F-453F-BBB7-52C516E7D66E}"/>
              </a:ext>
            </a:extLst>
          </p:cNvPr>
          <p:cNvSpPr txBox="1"/>
          <p:nvPr/>
        </p:nvSpPr>
        <p:spPr>
          <a:xfrm>
            <a:off x="2033708" y="124281"/>
            <a:ext cx="738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PBS-injected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A9D9385-BF2A-47E3-A34A-4C657B1EB62D}"/>
              </a:ext>
            </a:extLst>
          </p:cNvPr>
          <p:cNvCxnSpPr/>
          <p:nvPr/>
        </p:nvCxnSpPr>
        <p:spPr>
          <a:xfrm>
            <a:off x="2089271" y="572782"/>
            <a:ext cx="60682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E9CAD6C-62B5-45B8-BACF-F65360D36213}"/>
              </a:ext>
            </a:extLst>
          </p:cNvPr>
          <p:cNvCxnSpPr/>
          <p:nvPr/>
        </p:nvCxnSpPr>
        <p:spPr>
          <a:xfrm>
            <a:off x="1605404" y="1766727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5D1DBF43-7021-4ABE-B414-9BA72CF39485}"/>
              </a:ext>
            </a:extLst>
          </p:cNvPr>
          <p:cNvSpPr txBox="1"/>
          <p:nvPr/>
        </p:nvSpPr>
        <p:spPr>
          <a:xfrm>
            <a:off x="1316536" y="1633379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C6EF261-ED64-4ECE-9414-C893048B17CA}"/>
              </a:ext>
            </a:extLst>
          </p:cNvPr>
          <p:cNvSpPr txBox="1"/>
          <p:nvPr/>
        </p:nvSpPr>
        <p:spPr>
          <a:xfrm>
            <a:off x="2829505" y="124281"/>
            <a:ext cx="15202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KPC tumor-bearing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69A14265-88AF-4040-A9CE-016E60B359D7}"/>
              </a:ext>
            </a:extLst>
          </p:cNvPr>
          <p:cNvCxnSpPr/>
          <p:nvPr/>
        </p:nvCxnSpPr>
        <p:spPr>
          <a:xfrm>
            <a:off x="2780329" y="370617"/>
            <a:ext cx="15786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888B2574-DD3B-4012-B8BB-CD4D436F80F1}"/>
              </a:ext>
            </a:extLst>
          </p:cNvPr>
          <p:cNvSpPr txBox="1"/>
          <p:nvPr/>
        </p:nvSpPr>
        <p:spPr>
          <a:xfrm>
            <a:off x="4566984" y="2363968"/>
            <a:ext cx="851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MAFbx</a:t>
            </a:r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26B7B153-6ECD-47D5-9C22-C5AD3184869C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3" t="18912" r="3061" b="6711"/>
          <a:stretch/>
        </p:blipFill>
        <p:spPr>
          <a:xfrm>
            <a:off x="1666326" y="2127552"/>
            <a:ext cx="2931345" cy="84854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B9E923CF-A987-4F82-B65F-CA6D46B7C4F8}"/>
              </a:ext>
            </a:extLst>
          </p:cNvPr>
          <p:cNvCxnSpPr/>
          <p:nvPr/>
        </p:nvCxnSpPr>
        <p:spPr>
          <a:xfrm>
            <a:off x="1566915" y="2666528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49BAA0E-F5A9-4192-94BD-664CEFE97DB3}"/>
              </a:ext>
            </a:extLst>
          </p:cNvPr>
          <p:cNvSpPr txBox="1"/>
          <p:nvPr/>
        </p:nvSpPr>
        <p:spPr>
          <a:xfrm>
            <a:off x="1274279" y="2533180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5230F06-4766-43E8-82CB-0666CB936C2C}"/>
              </a:ext>
            </a:extLst>
          </p:cNvPr>
          <p:cNvSpPr txBox="1"/>
          <p:nvPr/>
        </p:nvSpPr>
        <p:spPr>
          <a:xfrm>
            <a:off x="4874408" y="3269172"/>
            <a:ext cx="851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MuRF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CF51931-87FA-482D-AB01-EEB874389D0C}"/>
              </a:ext>
            </a:extLst>
          </p:cNvPr>
          <p:cNvSpPr txBox="1"/>
          <p:nvPr/>
        </p:nvSpPr>
        <p:spPr>
          <a:xfrm>
            <a:off x="4785370" y="4570173"/>
            <a:ext cx="8516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p-STAT3</a:t>
            </a:r>
          </a:p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(Y705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EBBE908-541D-4207-95DC-87B5F1176598}"/>
              </a:ext>
            </a:extLst>
          </p:cNvPr>
          <p:cNvSpPr txBox="1"/>
          <p:nvPr/>
        </p:nvSpPr>
        <p:spPr>
          <a:xfrm>
            <a:off x="4699909" y="5134736"/>
            <a:ext cx="8516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805C75D-0479-4571-BFE2-25E9A44AD917}"/>
              </a:ext>
            </a:extLst>
          </p:cNvPr>
          <p:cNvCxnSpPr/>
          <p:nvPr/>
        </p:nvCxnSpPr>
        <p:spPr>
          <a:xfrm>
            <a:off x="1392331" y="4760068"/>
            <a:ext cx="44792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D84D034-C57B-429B-BA43-8A066F5D7F46}"/>
              </a:ext>
            </a:extLst>
          </p:cNvPr>
          <p:cNvSpPr txBox="1"/>
          <p:nvPr/>
        </p:nvSpPr>
        <p:spPr>
          <a:xfrm>
            <a:off x="1017322" y="4626720"/>
            <a:ext cx="485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C940B658-7949-40D9-BFC6-5D263C4E507B}"/>
              </a:ext>
            </a:extLst>
          </p:cNvPr>
          <p:cNvCxnSpPr/>
          <p:nvPr/>
        </p:nvCxnSpPr>
        <p:spPr>
          <a:xfrm>
            <a:off x="1567672" y="5364812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2CF6C257-2CD0-4614-BEFC-3E66CBC82A94}"/>
              </a:ext>
            </a:extLst>
          </p:cNvPr>
          <p:cNvSpPr txBox="1"/>
          <p:nvPr/>
        </p:nvSpPr>
        <p:spPr>
          <a:xfrm>
            <a:off x="1171150" y="5231464"/>
            <a:ext cx="4854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F5E4AB6-F3E1-4FDA-A133-7F75B9574F49}"/>
              </a:ext>
            </a:extLst>
          </p:cNvPr>
          <p:cNvCxnSpPr/>
          <p:nvPr/>
        </p:nvCxnSpPr>
        <p:spPr>
          <a:xfrm>
            <a:off x="1543229" y="3220933"/>
            <a:ext cx="33653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C83FB9E-675B-4209-839C-46AC47CC7FBE}"/>
              </a:ext>
            </a:extLst>
          </p:cNvPr>
          <p:cNvSpPr txBox="1"/>
          <p:nvPr/>
        </p:nvSpPr>
        <p:spPr>
          <a:xfrm>
            <a:off x="1250593" y="3087585"/>
            <a:ext cx="3815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8C2FC95-FB43-45D3-997C-C8B07A163B7E}"/>
              </a:ext>
            </a:extLst>
          </p:cNvPr>
          <p:cNvSpPr txBox="1"/>
          <p:nvPr/>
        </p:nvSpPr>
        <p:spPr>
          <a:xfrm>
            <a:off x="126985" y="0"/>
            <a:ext cx="7553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8I</a:t>
            </a:r>
          </a:p>
        </p:txBody>
      </p:sp>
      <p:pic>
        <p:nvPicPr>
          <p:cNvPr id="44" name="Picture 43">
            <a:extLst>
              <a:ext uri="{FF2B5EF4-FFF2-40B4-BE49-F238E27FC236}">
                <a16:creationId xmlns:a16="http://schemas.microsoft.com/office/drawing/2014/main" id="{743E1E22-9969-4723-8FC2-878CE2B7F08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80000"/>
                    </a14:imgEffect>
                    <a14:imgEffect>
                      <a14:brightnessContrast bright="-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41" t="2199" r="2700" b="9431"/>
          <a:stretch/>
        </p:blipFill>
        <p:spPr>
          <a:xfrm>
            <a:off x="1451914" y="3757932"/>
            <a:ext cx="3344157" cy="67392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CD79D18-238B-4514-8483-E4D3102C502D}"/>
              </a:ext>
            </a:extLst>
          </p:cNvPr>
          <p:cNvCxnSpPr/>
          <p:nvPr/>
        </p:nvCxnSpPr>
        <p:spPr>
          <a:xfrm>
            <a:off x="1417872" y="4058016"/>
            <a:ext cx="429055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5C0B4041-B527-4103-A17D-D1291CACF0FB}"/>
              </a:ext>
            </a:extLst>
          </p:cNvPr>
          <p:cNvSpPr txBox="1"/>
          <p:nvPr/>
        </p:nvSpPr>
        <p:spPr>
          <a:xfrm>
            <a:off x="1127642" y="3929041"/>
            <a:ext cx="365474" cy="267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9711C4D-E454-438D-9B84-F97D6E8D811F}"/>
              </a:ext>
            </a:extLst>
          </p:cNvPr>
          <p:cNvSpPr txBox="1"/>
          <p:nvPr/>
        </p:nvSpPr>
        <p:spPr>
          <a:xfrm>
            <a:off x="4796072" y="3827864"/>
            <a:ext cx="815774" cy="4465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C3b-I</a:t>
            </a:r>
          </a:p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LC3b-II</a:t>
            </a:r>
          </a:p>
        </p:txBody>
      </p:sp>
    </p:spTree>
    <p:extLst>
      <p:ext uri="{BB962C8B-B14F-4D97-AF65-F5344CB8AC3E}">
        <p14:creationId xmlns:p14="http://schemas.microsoft.com/office/powerpoint/2010/main" val="13164188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1</cp:revision>
  <dcterms:created xsi:type="dcterms:W3CDTF">2025-08-23T19:41:50Z</dcterms:created>
  <dcterms:modified xsi:type="dcterms:W3CDTF">2025-08-23T19:42:34Z</dcterms:modified>
</cp:coreProperties>
</file>